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08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74ED6"/>
    <a:srgbClr val="05BE78"/>
    <a:srgbClr val="FF8080"/>
    <a:srgbClr val="FFFFFF"/>
    <a:srgbClr val="0000FF"/>
    <a:srgbClr val="76069A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75"/>
    <p:restoredTop sz="94682"/>
  </p:normalViewPr>
  <p:slideViewPr>
    <p:cSldViewPr snapToGrid="0">
      <p:cViewPr varScale="1">
        <p:scale>
          <a:sx n="69" d="100"/>
          <a:sy n="69" d="100"/>
        </p:scale>
        <p:origin x="1788" y="84"/>
      </p:cViewPr>
      <p:guideLst>
        <p:guide orient="horz" pos="16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r">
              <a:defRPr sz="1200"/>
            </a:lvl1pPr>
          </a:lstStyle>
          <a:p>
            <a:fld id="{2781702D-12D0-4839-A3CC-B3169D578D6E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2225" y="1143000"/>
            <a:ext cx="1733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8" rIns="91435" bIns="4571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35" tIns="45718" rIns="91435" bIns="4571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r">
              <a:defRPr sz="1200"/>
            </a:lvl1pPr>
          </a:lstStyle>
          <a:p>
            <a:fld id="{6319DB23-573F-4C71-BB24-19F8F211E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4797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482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68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343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437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02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275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41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106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375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802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65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7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Picture 24">
            <a:extLst>
              <a:ext uri="{FF2B5EF4-FFF2-40B4-BE49-F238E27FC236}">
                <a16:creationId xmlns:a16="http://schemas.microsoft.com/office/drawing/2014/main" id="{D92159A6-59E3-6F7E-25A2-769BA3BBD1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834" y="1023963"/>
            <a:ext cx="3097304" cy="3032133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5BAC1A4C-E4B2-70C7-63A9-62396B1DE571}"/>
              </a:ext>
            </a:extLst>
          </p:cNvPr>
          <p:cNvSpPr txBox="1"/>
          <p:nvPr/>
        </p:nvSpPr>
        <p:spPr>
          <a:xfrm>
            <a:off x="4145936" y="742028"/>
            <a:ext cx="1753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154305">
              <a:spcAft>
                <a:spcPts val="338"/>
              </a:spcAft>
            </a:pP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NSG post radiation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AA7D8B2-A001-972D-52CE-D4805B7B9EBF}"/>
              </a:ext>
            </a:extLst>
          </p:cNvPr>
          <p:cNvSpPr txBox="1"/>
          <p:nvPr/>
        </p:nvSpPr>
        <p:spPr>
          <a:xfrm>
            <a:off x="535919" y="742028"/>
            <a:ext cx="26713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154305">
              <a:spcAft>
                <a:spcPts val="338"/>
              </a:spcAft>
            </a:pP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Hu-CD34+ post radiation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85B3CAD-3E42-0014-892A-871B0E667BC3}"/>
              </a:ext>
            </a:extLst>
          </p:cNvPr>
          <p:cNvSpPr txBox="1"/>
          <p:nvPr/>
        </p:nvSpPr>
        <p:spPr>
          <a:xfrm>
            <a:off x="2609976" y="3527947"/>
            <a:ext cx="597309" cy="276999"/>
          </a:xfrm>
          <a:prstGeom prst="rect">
            <a:avLst/>
          </a:prstGeom>
          <a:solidFill>
            <a:schemeClr val="bg1"/>
          </a:solidFill>
          <a:ln w="15875"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pPr defTabSz="154305">
              <a:spcAft>
                <a:spcPts val="338"/>
              </a:spcAft>
            </a:pP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A673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EDA957DC-BF30-64D0-4499-EAB92506BF70}"/>
              </a:ext>
            </a:extLst>
          </p:cNvPr>
          <p:cNvGrpSpPr/>
          <p:nvPr/>
        </p:nvGrpSpPr>
        <p:grpSpPr>
          <a:xfrm>
            <a:off x="3537682" y="1051723"/>
            <a:ext cx="3320318" cy="3032133"/>
            <a:chOff x="3652568" y="566168"/>
            <a:chExt cx="2732888" cy="2367782"/>
          </a:xfrm>
        </p:grpSpPr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B46886B5-C803-A643-CB6F-2B33D6BFEA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12002"/>
            <a:stretch/>
          </p:blipFill>
          <p:spPr>
            <a:xfrm>
              <a:off x="3652568" y="566168"/>
              <a:ext cx="2442737" cy="2367782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77E85E5C-4F11-D54C-AAC2-328DEF11F745}"/>
                </a:ext>
              </a:extLst>
            </p:cNvPr>
            <p:cNvSpPr txBox="1"/>
            <p:nvPr/>
          </p:nvSpPr>
          <p:spPr>
            <a:xfrm>
              <a:off x="5533032" y="731411"/>
              <a:ext cx="852424" cy="1922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CD74</a:t>
              </a:r>
            </a:p>
          </p:txBody>
        </p: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CDB6CF11-7654-F641-5860-643A085CE720}"/>
                </a:ext>
              </a:extLst>
            </p:cNvPr>
            <p:cNvCxnSpPr>
              <a:cxnSpLocks/>
            </p:cNvCxnSpPr>
            <p:nvPr/>
          </p:nvCxnSpPr>
          <p:spPr>
            <a:xfrm>
              <a:off x="5327113" y="701448"/>
              <a:ext cx="269246" cy="11107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81E48968-7E84-FC45-BBC0-D60BC61B463D}"/>
              </a:ext>
            </a:extLst>
          </p:cNvPr>
          <p:cNvSpPr txBox="1"/>
          <p:nvPr/>
        </p:nvSpPr>
        <p:spPr>
          <a:xfrm>
            <a:off x="5828409" y="3527947"/>
            <a:ext cx="557644" cy="276999"/>
          </a:xfrm>
          <a:prstGeom prst="rect">
            <a:avLst/>
          </a:prstGeom>
          <a:solidFill>
            <a:schemeClr val="bg1"/>
          </a:solidFill>
          <a:ln w="15875"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pPr defTabSz="154305">
              <a:spcAft>
                <a:spcPts val="338"/>
              </a:spcAft>
            </a:pP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A673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0C24485-F3BE-1950-AFC9-E233761466D1}"/>
              </a:ext>
            </a:extLst>
          </p:cNvPr>
          <p:cNvSpPr txBox="1"/>
          <p:nvPr/>
        </p:nvSpPr>
        <p:spPr>
          <a:xfrm>
            <a:off x="279419" y="4288023"/>
            <a:ext cx="6516526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145540" algn="l"/>
              </a:tabLst>
            </a:pPr>
            <a:r>
              <a:rPr lang="en-US" sz="11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12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Transcriptional modulation induced following radiation in A673 Ewing sarcoma tumors developed in hu-CD34+ versus NSG mice. 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RNA was extracted from tumors post sacrifice and bulk RNA sequencing was performed. Volcano plots demonstrating differential gene expression post radiation of A673 tumors derived in either hu-CD34+ or NSG mice are shown.</a:t>
            </a:r>
            <a:endParaRPr lang="en-US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1752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9ef9f489-e0a0-4eeb-87cc-3a526112fd0d}" enabled="0" method="" siteId="{9ef9f489-e0a0-4eeb-87cc-3a526112fd0d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67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ley, Jessica</dc:creator>
  <cp:lastModifiedBy>Bailey, Kelly Margaret</cp:lastModifiedBy>
  <cp:revision>5</cp:revision>
  <cp:lastPrinted>2025-05-16T17:21:58Z</cp:lastPrinted>
  <dcterms:created xsi:type="dcterms:W3CDTF">2024-03-08T16:05:53Z</dcterms:created>
  <dcterms:modified xsi:type="dcterms:W3CDTF">2025-07-22T15:12:28Z</dcterms:modified>
</cp:coreProperties>
</file>